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000" autoAdjust="0"/>
    <p:restoredTop sz="94660"/>
  </p:normalViewPr>
  <p:slideViewPr>
    <p:cSldViewPr snapToGrid="0">
      <p:cViewPr varScale="1">
        <p:scale>
          <a:sx n="111" d="100"/>
          <a:sy n="111" d="100"/>
        </p:scale>
        <p:origin x="384" y="19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C3A8AD-D66A-4790-9B21-209B1E6E255A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6/21/19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E72BBC-3E01-4A7D-9F94-57897BFE4F7A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90025856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C3A8AD-D66A-4790-9B21-209B1E6E255A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6/21/19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E72BBC-3E01-4A7D-9F94-57897BFE4F7A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01874033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C3A8AD-D66A-4790-9B21-209B1E6E255A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6/21/19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E72BBC-3E01-4A7D-9F94-57897BFE4F7A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85032290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C3A8AD-D66A-4790-9B21-209B1E6E255A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6/21/19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E72BBC-3E01-4A7D-9F94-57897BFE4F7A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35032661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C3A8AD-D66A-4790-9B21-209B1E6E255A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6/21/19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E72BBC-3E01-4A7D-9F94-57897BFE4F7A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70956036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C3A8AD-D66A-4790-9B21-209B1E6E255A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6/21/19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E72BBC-3E01-4A7D-9F94-57897BFE4F7A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11245079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C3A8AD-D66A-4790-9B21-209B1E6E255A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6/21/19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E72BBC-3E01-4A7D-9F94-57897BFE4F7A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91172062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C3A8AD-D66A-4790-9B21-209B1E6E255A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6/21/19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E72BBC-3E01-4A7D-9F94-57897BFE4F7A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39822881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C3A8AD-D66A-4790-9B21-209B1E6E255A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6/21/19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E72BBC-3E01-4A7D-9F94-57897BFE4F7A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14832668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C3A8AD-D66A-4790-9B21-209B1E6E255A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6/21/19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E72BBC-3E01-4A7D-9F94-57897BFE4F7A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83727332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C3A8AD-D66A-4790-9B21-209B1E6E255A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6/21/19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E72BBC-3E01-4A7D-9F94-57897BFE4F7A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07512055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7C3A8AD-D66A-4790-9B21-209B1E6E255A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6/21/19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CE72BBC-3E01-4A7D-9F94-57897BFE4F7A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81962603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750A55BA-70D8-D647-9CBF-566DC96B9325}"/>
              </a:ext>
            </a:extLst>
          </p:cNvPr>
          <p:cNvSpPr txBox="1"/>
          <p:nvPr/>
        </p:nvSpPr>
        <p:spPr>
          <a:xfrm>
            <a:off x="341194" y="342426"/>
            <a:ext cx="216379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prstClr val="black"/>
                </a:solidFill>
              </a:rPr>
              <a:t>Supplementary </a:t>
            </a:r>
            <a:r>
              <a:rPr lang="en-US">
                <a:solidFill>
                  <a:prstClr val="black"/>
                </a:solidFill>
              </a:rPr>
              <a:t>File 1</a:t>
            </a:r>
            <a:endParaRPr lang="en-US" dirty="0">
              <a:solidFill>
                <a:prstClr val="black"/>
              </a:solidFill>
            </a:endParaRPr>
          </a:p>
        </p:txBody>
      </p:sp>
      <p:graphicFrame>
        <p:nvGraphicFramePr>
          <p:cNvPr id="3" name="Table 2"/>
          <p:cNvGraphicFramePr>
            <a:graphicFrameLocks noGrp="1"/>
          </p:cNvGraphicFramePr>
          <p:nvPr/>
        </p:nvGraphicFramePr>
        <p:xfrm>
          <a:off x="341193" y="924476"/>
          <a:ext cx="6988327" cy="4060392"/>
        </p:xfrm>
        <a:graphic>
          <a:graphicData uri="http://schemas.openxmlformats.org/drawingml/2006/table">
            <a:tbl>
              <a:tblPr/>
              <a:tblGrid>
                <a:gridCol w="1297826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2846717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2843784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</a:tblGrid>
              <a:tr h="290028">
                <a:tc gridSpan="3"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rimer sequences</a:t>
                      </a:r>
                    </a:p>
                  </a:txBody>
                  <a:tcPr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290028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arget sequence</a:t>
                      </a:r>
                    </a:p>
                  </a:txBody>
                  <a:tcPr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' primer</a:t>
                      </a:r>
                    </a:p>
                  </a:txBody>
                  <a:tcPr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' primer</a:t>
                      </a:r>
                    </a:p>
                  </a:txBody>
                  <a:tcPr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290028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OT-1</a:t>
                      </a:r>
                    </a:p>
                  </a:txBody>
                  <a:tcPr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AAGGTGGATGTGGAGGGAAAG</a:t>
                      </a:r>
                    </a:p>
                  </a:txBody>
                  <a:tcPr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AAAGGACAGCAGTGAGCAAGG</a:t>
                      </a:r>
                    </a:p>
                  </a:txBody>
                  <a:tcPr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290028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OT-2</a:t>
                      </a:r>
                    </a:p>
                  </a:txBody>
                  <a:tcPr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AAGGTGGATGTGGAGGGAAAG</a:t>
                      </a:r>
                    </a:p>
                  </a:txBody>
                  <a:tcPr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AAAGGACAGCAGTGAGCAAGG</a:t>
                      </a:r>
                    </a:p>
                  </a:txBody>
                  <a:tcPr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290028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OT-3</a:t>
                      </a:r>
                    </a:p>
                  </a:txBody>
                  <a:tcPr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AGGGATCTTCTGAGAGAGCAGATC</a:t>
                      </a:r>
                    </a:p>
                  </a:txBody>
                  <a:tcPr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agtgctctcccccactttctg</a:t>
                      </a:r>
                    </a:p>
                  </a:txBody>
                  <a:tcPr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290028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OT-4</a:t>
                      </a:r>
                    </a:p>
                  </a:txBody>
                  <a:tcPr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CTATGGGAAAACAGAGTTGGTC</a:t>
                      </a:r>
                    </a:p>
                  </a:txBody>
                  <a:tcPr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TTGGAGGGTGTGTGGAGAG</a:t>
                      </a:r>
                    </a:p>
                  </a:txBody>
                  <a:tcPr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290028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OT-5</a:t>
                      </a:r>
                    </a:p>
                  </a:txBody>
                  <a:tcPr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acagcaaaaggaggtcaaagg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attgcttttggcgaagtgg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290028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OT-6</a:t>
                      </a:r>
                    </a:p>
                  </a:txBody>
                  <a:tcPr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TGATGCCAGCTTGGAGTCAG</a:t>
                      </a:r>
                    </a:p>
                  </a:txBody>
                  <a:tcPr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gcagaggccatgaaggag</a:t>
                      </a:r>
                    </a:p>
                  </a:txBody>
                  <a:tcPr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290028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OT-7</a:t>
                      </a:r>
                    </a:p>
                  </a:txBody>
                  <a:tcPr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GTAATTTGTGTCATGAAAATACTTGT</a:t>
                      </a:r>
                    </a:p>
                  </a:txBody>
                  <a:tcPr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acatacaTATTCAAAAAGATCACTTG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290028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OT-8</a:t>
                      </a:r>
                    </a:p>
                  </a:txBody>
                  <a:tcPr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CCCCTACTAAGAGGTGGGTCTC</a:t>
                      </a:r>
                    </a:p>
                  </a:txBody>
                  <a:tcPr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TGAGAAAGGCTGACCAAGAAG</a:t>
                      </a:r>
                    </a:p>
                  </a:txBody>
                  <a:tcPr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  <a:tr h="290028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OT-9</a:t>
                      </a:r>
                    </a:p>
                  </a:txBody>
                  <a:tcPr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AAACTCCAGAGTCCTTTGATTGG</a:t>
                      </a:r>
                    </a:p>
                  </a:txBody>
                  <a:tcPr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TGCTTCTGCCAAGTCTCCTG</a:t>
                      </a:r>
                    </a:p>
                  </a:txBody>
                  <a:tcPr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10"/>
                  </a:ext>
                </a:extLst>
              </a:tr>
              <a:tr h="290028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OT-10</a:t>
                      </a:r>
                    </a:p>
                  </a:txBody>
                  <a:tcPr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GACTCTCAGACTTGGCTTCTC</a:t>
                      </a:r>
                    </a:p>
                  </a:txBody>
                  <a:tcPr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GTACACCATTAGGCACAGG</a:t>
                      </a:r>
                    </a:p>
                  </a:txBody>
                  <a:tcPr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11"/>
                  </a:ext>
                </a:extLst>
              </a:tr>
              <a:tr h="290028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OT-11</a:t>
                      </a:r>
                    </a:p>
                  </a:txBody>
                  <a:tcPr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AACCTTTGTCCCAGCACTC</a:t>
                      </a:r>
                    </a:p>
                  </a:txBody>
                  <a:tcPr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cccttgtcacagtatagcaagtc</a:t>
                      </a:r>
                    </a:p>
                  </a:txBody>
                  <a:tcPr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12"/>
                  </a:ext>
                </a:extLst>
              </a:tr>
              <a:tr h="290028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OT-12</a:t>
                      </a:r>
                    </a:p>
                  </a:txBody>
                  <a:tcPr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TATGACCCGTGTCTCCATCAG</a:t>
                      </a:r>
                    </a:p>
                  </a:txBody>
                  <a:tcPr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GGAAAGCCTGTTCTGACCTTG</a:t>
                      </a:r>
                    </a:p>
                  </a:txBody>
                  <a:tcPr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13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273358577"/>
      </p:ext>
    </p:extLst>
  </p:cSld>
  <p:clrMapOvr>
    <a:masterClrMapping/>
  </p:clrMapOvr>
</p:sld>
</file>

<file path=ppt/theme/theme1.xml><?xml version="1.0" encoding="utf-8"?>
<a:theme xmlns:a="http://schemas.openxmlformats.org/drawingml/2006/main" name="3_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50</Words>
  <Application>Microsoft Macintosh PowerPoint</Application>
  <PresentationFormat>Widescreen</PresentationFormat>
  <Paragraphs>4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3_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oloney, Rachel (molonerd)</dc:creator>
  <cp:lastModifiedBy>eLife Sciences</cp:lastModifiedBy>
  <cp:revision>2</cp:revision>
  <dcterms:created xsi:type="dcterms:W3CDTF">2019-06-18T20:29:08Z</dcterms:created>
  <dcterms:modified xsi:type="dcterms:W3CDTF">2019-06-21T18:18:35Z</dcterms:modified>
</cp:coreProperties>
</file>